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30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ABB96"/>
    <a:srgbClr val="BBBBBB"/>
    <a:srgbClr val="00FB92"/>
    <a:srgbClr val="73FD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854"/>
    <p:restoredTop sz="95946"/>
  </p:normalViewPr>
  <p:slideViewPr>
    <p:cSldViewPr snapToGrid="0">
      <p:cViewPr varScale="1">
        <p:scale>
          <a:sx n="85" d="100"/>
          <a:sy n="85" d="100"/>
        </p:scale>
        <p:origin x="208" y="8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3ED2A0E-4BC0-8EEE-51F1-EB6F3586FF1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8085A0D-8A50-5624-2FD6-F33F95ED642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858547-0E6A-5E3A-5C6C-DE3BD22F29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C160D09-02C8-84D0-AF60-E365A5896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5A72235-4C65-32E4-99AE-63F40954F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56424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478BB0-9CA2-4C22-9738-4F04AE28E2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7B69E49-4681-82C9-DB25-DF5584B52A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E2A9F95-B2EE-8300-7192-F6F9225331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6520F89-7991-B051-679B-1915F38C1C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C638CCD-51D6-599D-DCEA-6D85646F93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675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3BDA13E-C6B9-78DC-58C3-7324741611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32842298-FCA1-4834-B188-F5FAC7B018D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64955DB-5E6D-400B-54AE-59EF434090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5B85984-5618-7280-B9EC-C42CD15B3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F097997-0E2A-8BBB-008F-B86415F1A3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8769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DF3D761-F3D4-7A37-539A-280BCA3B2A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0514BD8-43D0-F3FE-CFB7-A68EDAA5EC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89A29BA-C3D7-400F-7955-E4157CC2E2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86851E5-2A01-FEE1-C3A9-21B0D7130B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1AB6BF-5096-4B1B-3650-CCBF891B46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4219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5FC360-C5BD-C43F-3AA7-7B096415D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838F160-6B50-FEAC-905D-7C554A68D8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CCA2B72-8168-028A-BF07-A3FDE9DA4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ACF4D8-B8D0-7899-A1C1-D8B87090A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3AF14A8-944B-4FC2-2066-097B72826A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150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ADA566-8732-B1E7-7791-240D9CBD15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8502F8A-2448-84A3-5DD3-41E55E8B2E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160955A-9FFF-7AF8-D303-D5E7A335D0D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FFB722C-710D-731B-D4BA-67F52A2782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5D6B78E-5F81-179F-3A27-05CF262B61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B471E98-F15B-F632-FBF1-A58151174B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47225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CDE415-786D-7919-D210-FCA3DF6C12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DF1EAA8-C84F-EBE5-FEB1-7A86475657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38A0516-8B99-8BB8-7EAC-0760BCBF6D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E2D483F-F31D-AC73-0773-F19CCC2B45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D1F3715-5275-A574-F5C0-1060F13DA0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85420AD-0DE5-7E43-19E0-B5A8293DA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CEE09260-C535-C6B4-AF1D-61289811CC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12C7C66-0D56-E313-BB37-28FEC6DD7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84450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5C96C95-E51F-12A5-65C8-AF076C0610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C4D9A046-DBD5-8DDB-5FEF-E746260F2A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4D45EAA-2883-FB3E-0758-1BABC6AB0C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A592911-4FAF-D5AB-4AC5-ACAB7CB81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5398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56F76FDA-0165-0820-ADD3-EA720461F0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DBA6DDCC-520E-4C01-F4AF-C96C36B0A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135EC396-620D-4080-6C5F-98EE66EA95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58229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D20698B-4886-2F46-876A-96FA031F6C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C4B4DB4-E0C6-F455-54B4-7B8924F855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FDA4ACC-01BB-A3B0-97E6-7BB3D90524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90F9F99-B1D2-E6AA-C7D4-6464021B5A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FEA6910-F5F0-E433-07A5-DF49FD8E55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C9FC872-3A06-F741-CE7E-369E5582FA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1261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CBA73B1-F950-5B7B-772F-0DE2EADB09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ED2F752-A34D-01DF-24DD-D2C159DF955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C73A605-EEC6-AFA2-8350-D4EFEC5164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352AACD-DFFA-F68C-09AB-FB88BF0C3A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84A387A-0BB0-B965-4845-9B02112566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78A2E0E-AED2-40FF-C22D-DED1CB1E5C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19562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402B5D6-4D9F-02EE-AB4D-F80EB0DE19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85B2AE0-172E-CAA8-1445-F56B838ECF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BB68646-A4E5-B98E-024F-A18FCBA54C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72E98D-CA9A-5240-B357-0353D239F6E4}" type="datetimeFigureOut">
              <a:rPr kumimoji="1" lang="ja-JP" altLang="en-US" smtClean="0"/>
              <a:t>2022/9/22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E855A7-78FF-DE92-7725-D64C60F248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9F1DB7C-5A08-0C7B-3CCC-C3308E8D97B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A4B3B3-541E-7449-BE24-295640172BB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27438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2550DC61-FD5C-D835-C661-93ABDE7E3DFE}"/>
              </a:ext>
            </a:extLst>
          </p:cNvPr>
          <p:cNvSpPr txBox="1"/>
          <p:nvPr/>
        </p:nvSpPr>
        <p:spPr>
          <a:xfrm>
            <a:off x="63111" y="4784480"/>
            <a:ext cx="121031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S1 Fig.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anscriptome profiling of RNA-seq reads 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ed from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HM-1 analysis in 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xenic and monoxenic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nditions to investigate the impact of </a:t>
            </a:r>
            <a:r>
              <a:rPr kumimoji="1"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fasciculata </a:t>
            </a:r>
            <a:r>
              <a:rPr kumimoji="1"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 the gene expression of </a:t>
            </a:r>
            <a:r>
              <a:rPr kumimoji="1"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 histolytica</a:t>
            </a:r>
            <a:r>
              <a:rPr lang="en-US" altLang="ja-JP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Principal component analysis of the RNA-seq reads. B</a:t>
            </a:r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Volcano plot showing DEGs of the HM-1 between axenic and monoxenic condition. C. Heat map showing the clustering of each condition.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1" name="図 40">
            <a:extLst>
              <a:ext uri="{FF2B5EF4-FFF2-40B4-BE49-F238E27FC236}">
                <a16:creationId xmlns:a16="http://schemas.microsoft.com/office/drawing/2014/main" id="{EC36A24F-117A-9877-FD48-579997CF04D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450" y="947835"/>
            <a:ext cx="12103100" cy="3581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26371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6</TotalTime>
  <Words>71</Words>
  <Application>Microsoft Macintosh PowerPoint</Application>
  <PresentationFormat>ワイド画面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nagawa Yasuaki</dc:creator>
  <cp:lastModifiedBy>Yanagawa Yasuaki</cp:lastModifiedBy>
  <cp:revision>13</cp:revision>
  <dcterms:created xsi:type="dcterms:W3CDTF">2022-07-28T19:08:18Z</dcterms:created>
  <dcterms:modified xsi:type="dcterms:W3CDTF">2022-09-22T22:56:06Z</dcterms:modified>
</cp:coreProperties>
</file>